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62" d="100"/>
          <a:sy n="62" d="100"/>
        </p:scale>
        <p:origin x="-1376" y="-6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storage.erasmusmc.nl\v\vcl13\MAGE\DATA\UserData\248018\Article\Effect%20of%20financial%20support%20on%20reducing%20the%20incidence%20of%20catastrophic%20costs%20among%20tuberculosis-affected%20households%20in%20Indonesia\4%20Analysis\Figure%202%20and%20Supplements%20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storage.erasmusmc.nl\v\vcl13\MAGE\DATA\UserData\248018\Article\Effect%20of%20financial%20support%20on%20reducing%20the%20incidence%20of%20catastrophic%20costs%20among%20tuberculosis-affected%20households%20in%20Indonesia\4%20Analysis\Figure%202%20and%20Supplements%20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storage.erasmusmc.nl\v\vcl13\MAGE\DATA\UserData\248018\Article\Effect%20of%20financial%20support%20on%20reducing%20the%20incidence%20of%20catastrophic%20costs%20among%20tuberculosis-affected%20households%20in%20Indonesia\4%20Analysis\Figure%202%20and%20Supplements%20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storage.erasmusmc.nl\v\vcl13\MAGE\DATA\UserData\248018\Article\Effect%20of%20financial%20support%20on%20reducing%20the%20incidence%20of%20catastrophic%20costs%20among%20tuberculosis-affected%20households%20in%20Indonesia\4%20Analysis\Figure%202%20and%20Supplements%20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/>
      <c:barChart>
        <c:barDir val="col"/>
        <c:grouping val="clustered"/>
        <c:ser>
          <c:idx val="0"/>
          <c:order val="0"/>
          <c:tx>
            <c:v>Poor</c:v>
          </c:tx>
          <c:errBars>
            <c:errBarType val="both"/>
            <c:errValType val="cust"/>
            <c:plus>
              <c:numRef>
                <c:f>('Figure MDR-TB'!$D$11;'Figure MDR-TB'!$H$11;'Figure MDR-TB'!$L$11;'Figure MDR-TB'!$P$11;'Figure MDR-TB'!$T$11;'Figure MDR-TB'!$X$11;'Figure MDR-TB'!$AB$11;'Figure MDR-TB'!$AF$11)</c:f>
                <c:numCache>
                  <c:formatCode>General</c:formatCode>
                  <c:ptCount val="8"/>
                  <c:pt idx="0">
                    <c:v>8.0529420800537075</c:v>
                  </c:pt>
                  <c:pt idx="1">
                    <c:v>10.5</c:v>
                  </c:pt>
                  <c:pt idx="2">
                    <c:v>9.4</c:v>
                  </c:pt>
                  <c:pt idx="3">
                    <c:v>10.089330252452182</c:v>
                  </c:pt>
                  <c:pt idx="4">
                    <c:v>10.4</c:v>
                  </c:pt>
                  <c:pt idx="5">
                    <c:v>8.9</c:v>
                  </c:pt>
                  <c:pt idx="6">
                    <c:v>10.4</c:v>
                  </c:pt>
                  <c:pt idx="7">
                    <c:v>8.8750898170448611</c:v>
                  </c:pt>
                </c:numCache>
              </c:numRef>
            </c:plus>
            <c:minus>
              <c:numRef>
                <c:f>('Figure MDR-TB'!$D$11;'Figure MDR-TB'!$H$11;'Figure MDR-TB'!$L$11;'Figure MDR-TB'!$P$11;'Figure MDR-TB'!$T$11;'Figure MDR-TB'!$X$11;'Figure MDR-TB'!$AB$11;'Figure MDR-TB'!$AF$11)</c:f>
                <c:numCache>
                  <c:formatCode>General</c:formatCode>
                  <c:ptCount val="8"/>
                  <c:pt idx="0">
                    <c:v>8.0529420800537075</c:v>
                  </c:pt>
                  <c:pt idx="1">
                    <c:v>10.5</c:v>
                  </c:pt>
                  <c:pt idx="2">
                    <c:v>9.4</c:v>
                  </c:pt>
                  <c:pt idx="3">
                    <c:v>10.089330252452182</c:v>
                  </c:pt>
                  <c:pt idx="4">
                    <c:v>10.4</c:v>
                  </c:pt>
                  <c:pt idx="5">
                    <c:v>8.9</c:v>
                  </c:pt>
                  <c:pt idx="6">
                    <c:v>10.4</c:v>
                  </c:pt>
                  <c:pt idx="7">
                    <c:v>8.8750898170448611</c:v>
                  </c:pt>
                </c:numCache>
              </c:numRef>
            </c:minus>
          </c:errBars>
          <c:cat>
            <c:strRef>
              <c:f>('Figure MDR-TB'!$C$9;'Figure MDR-TB'!$G$9;'Figure MDR-TB'!$K$9;'Figure MDR-TB'!$O$9;'Figure MDR-TB'!$S$9;'Figure MDR-TB'!$W$9;'Figure MDR-TB'!$AA$9;'Figure MDR-TB'!$AE$9)</c:f>
              <c:strCache>
                <c:ptCount val="8"/>
                <c:pt idx="0">
                  <c:v>I</c:v>
                </c:pt>
                <c:pt idx="1">
                  <c:v>II</c:v>
                </c:pt>
                <c:pt idx="2">
                  <c:v>III</c:v>
                </c:pt>
                <c:pt idx="3">
                  <c:v>IV</c:v>
                </c:pt>
                <c:pt idx="4">
                  <c:v>V</c:v>
                </c:pt>
                <c:pt idx="5">
                  <c:v>VI</c:v>
                </c:pt>
                <c:pt idx="6">
                  <c:v>VII</c:v>
                </c:pt>
                <c:pt idx="7">
                  <c:v>VIII</c:v>
                </c:pt>
              </c:strCache>
            </c:strRef>
          </c:cat>
          <c:val>
            <c:numRef>
              <c:f>('Figure MDR-TB'!$C$11;'Figure MDR-TB'!$G$11;'Figure MDR-TB'!$K$11;'Figure MDR-TB'!$O$11;'Figure MDR-TB'!$S$11;'Figure MDR-TB'!$W$11;'Figure MDR-TB'!$AA$11;'Figure MDR-TB'!$AE$11)</c:f>
              <c:numCache>
                <c:formatCode>###0.0</c:formatCode>
                <c:ptCount val="8"/>
                <c:pt idx="0">
                  <c:v>82.608695652173878</c:v>
                </c:pt>
                <c:pt idx="1">
                  <c:v>43.5</c:v>
                </c:pt>
                <c:pt idx="2">
                  <c:v>73.913043478260931</c:v>
                </c:pt>
                <c:pt idx="3">
                  <c:v>65.217391304347871</c:v>
                </c:pt>
                <c:pt idx="4">
                  <c:v>56.52173913043481</c:v>
                </c:pt>
                <c:pt idx="5">
                  <c:v>21.7</c:v>
                </c:pt>
                <c:pt idx="6">
                  <c:v>56.52173913043481</c:v>
                </c:pt>
                <c:pt idx="7">
                  <c:v>21.739130434782609</c:v>
                </c:pt>
              </c:numCache>
            </c:numRef>
          </c:val>
        </c:ser>
        <c:ser>
          <c:idx val="1"/>
          <c:order val="1"/>
          <c:tx>
            <c:v>Non-Poor</c:v>
          </c:tx>
          <c:errBars>
            <c:errBarType val="both"/>
            <c:errValType val="cust"/>
            <c:plus>
              <c:numRef>
                <c:f>('Figure MDR-TB'!$F$11;'Figure MDR-TB'!$J$11;'Figure MDR-TB'!$N$11;'Figure MDR-TB'!$R$11;'Figure MDR-TB'!$V$11;'Figure MDR-TB'!$Z$11;'Figure MDR-TB'!$AD$11;'Figure MDR-TB'!$AH$11)</c:f>
                <c:numCache>
                  <c:formatCode>General</c:formatCode>
                  <c:ptCount val="8"/>
                  <c:pt idx="0">
                    <c:v>5.7962026592393734</c:v>
                  </c:pt>
                  <c:pt idx="1">
                    <c:v>7.1</c:v>
                  </c:pt>
                  <c:pt idx="2">
                    <c:v>6.3</c:v>
                  </c:pt>
                  <c:pt idx="3">
                    <c:v>8</c:v>
                  </c:pt>
                  <c:pt idx="4">
                    <c:v>8.2000000000000011</c:v>
                  </c:pt>
                  <c:pt idx="5">
                    <c:v>7.7</c:v>
                  </c:pt>
                  <c:pt idx="6">
                    <c:v>8.2000000000000011</c:v>
                  </c:pt>
                  <c:pt idx="7">
                    <c:v>7.5712114138568163</c:v>
                  </c:pt>
                </c:numCache>
              </c:numRef>
            </c:plus>
            <c:minus>
              <c:numRef>
                <c:f>('Figure MDR-TB'!$F$11;'Figure MDR-TB'!$J$11;'Figure MDR-TB'!$N$11;'Figure MDR-TB'!$R$11;'Figure MDR-TB'!$V$11;'Figure MDR-TB'!$Z$11;'Figure MDR-TB'!$AD$11;'Figure MDR-TB'!$AH$11)</c:f>
                <c:numCache>
                  <c:formatCode>General</c:formatCode>
                  <c:ptCount val="8"/>
                  <c:pt idx="0">
                    <c:v>5.7962026592393734</c:v>
                  </c:pt>
                  <c:pt idx="1">
                    <c:v>7.1</c:v>
                  </c:pt>
                  <c:pt idx="2">
                    <c:v>6.3</c:v>
                  </c:pt>
                  <c:pt idx="3">
                    <c:v>8</c:v>
                  </c:pt>
                  <c:pt idx="4">
                    <c:v>8.2000000000000011</c:v>
                  </c:pt>
                  <c:pt idx="5">
                    <c:v>7.7</c:v>
                  </c:pt>
                  <c:pt idx="6">
                    <c:v>8.2000000000000011</c:v>
                  </c:pt>
                  <c:pt idx="7">
                    <c:v>7.5712114138568163</c:v>
                  </c:pt>
                </c:numCache>
              </c:numRef>
            </c:minus>
          </c:errBars>
          <c:cat>
            <c:strRef>
              <c:f>('Figure MDR-TB'!$C$9;'Figure MDR-TB'!$G$9;'Figure MDR-TB'!$K$9;'Figure MDR-TB'!$O$9;'Figure MDR-TB'!$S$9;'Figure MDR-TB'!$W$9;'Figure MDR-TB'!$AA$9;'Figure MDR-TB'!$AE$9)</c:f>
              <c:strCache>
                <c:ptCount val="8"/>
                <c:pt idx="0">
                  <c:v>I</c:v>
                </c:pt>
                <c:pt idx="1">
                  <c:v>II</c:v>
                </c:pt>
                <c:pt idx="2">
                  <c:v>III</c:v>
                </c:pt>
                <c:pt idx="3">
                  <c:v>IV</c:v>
                </c:pt>
                <c:pt idx="4">
                  <c:v>V</c:v>
                </c:pt>
                <c:pt idx="5">
                  <c:v>VI</c:v>
                </c:pt>
                <c:pt idx="6">
                  <c:v>VII</c:v>
                </c:pt>
                <c:pt idx="7">
                  <c:v>VIII</c:v>
                </c:pt>
              </c:strCache>
            </c:strRef>
          </c:cat>
          <c:val>
            <c:numRef>
              <c:f>('Figure MDR-TB'!$E$11;'Figure MDR-TB'!$I$11;'Figure MDR-TB'!$M$11;'Figure MDR-TB'!$Q$11;'Figure MDR-TB'!$U$11;'Figure MDR-TB'!$Y$11;'Figure MDR-TB'!$AC$11;'Figure MDR-TB'!$AG$11)</c:f>
              <c:numCache>
                <c:formatCode>###0.0</c:formatCode>
                <c:ptCount val="8"/>
                <c:pt idx="0">
                  <c:v>82.926829268292735</c:v>
                </c:pt>
                <c:pt idx="1">
                  <c:v>73.2</c:v>
                </c:pt>
                <c:pt idx="2">
                  <c:v>80.487804878048777</c:v>
                </c:pt>
                <c:pt idx="3">
                  <c:v>60.975609756097533</c:v>
                </c:pt>
                <c:pt idx="4">
                  <c:v>56.097560975609753</c:v>
                </c:pt>
                <c:pt idx="5">
                  <c:v>39.024390243902438</c:v>
                </c:pt>
                <c:pt idx="6">
                  <c:v>53.658536585365852</c:v>
                </c:pt>
                <c:pt idx="7">
                  <c:v>36.6</c:v>
                </c:pt>
              </c:numCache>
            </c:numRef>
          </c:val>
        </c:ser>
        <c:axId val="188472704"/>
        <c:axId val="188621952"/>
      </c:barChart>
      <c:catAx>
        <c:axId val="188472704"/>
        <c:scaling>
          <c:orientation val="minMax"/>
        </c:scaling>
        <c:axPos val="b"/>
        <c:tickLblPos val="nextTo"/>
        <c:crossAx val="188621952"/>
        <c:crosses val="autoZero"/>
        <c:auto val="1"/>
        <c:lblAlgn val="ctr"/>
        <c:lblOffset val="100"/>
      </c:catAx>
      <c:valAx>
        <c:axId val="188621952"/>
        <c:scaling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Incidence of catastrophic costs (%)</a:t>
                </a:r>
              </a:p>
            </c:rich>
          </c:tx>
          <c:layout/>
        </c:title>
        <c:numFmt formatCode="#,##0" sourceLinked="0"/>
        <c:tickLblPos val="nextTo"/>
        <c:crossAx val="188472704"/>
        <c:crosses val="autoZero"/>
        <c:crossBetween val="between"/>
      </c:valAx>
    </c:plotArea>
    <c:plotVisOnly val="1"/>
    <c:dispBlanksAs val="gap"/>
  </c:chart>
  <c:txPr>
    <a:bodyPr/>
    <a:lstStyle/>
    <a:p>
      <a:pPr>
        <a:defRPr sz="900">
          <a:latin typeface="Myriad Pro Light" pitchFamily="34" charset="0"/>
          <a:cs typeface="Arial" panose="020B0604020202020204" pitchFamily="34" charset="0"/>
        </a:defRPr>
      </a:pPr>
      <a:endParaRPr lang="en-US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/>
      <c:barChart>
        <c:barDir val="col"/>
        <c:grouping val="clustered"/>
        <c:ser>
          <c:idx val="0"/>
          <c:order val="0"/>
          <c:tx>
            <c:v>Poor</c:v>
          </c:tx>
          <c:errBars>
            <c:errBarType val="both"/>
            <c:errValType val="cust"/>
            <c:plus>
              <c:numRef>
                <c:f>('Figure MDR-TB'!$D$16;'Figure MDR-TB'!$H$16;'Figure MDR-TB'!$L$16;'Figure MDR-TB'!$P$16;'Figure MDR-TB'!$T$16;'Figure MDR-TB'!$X$16;'Figure MDR-TB'!$AB$16;'Figure MDR-TB'!$AF$16)</c:f>
                <c:numCache>
                  <c:formatCode>General</c:formatCode>
                  <c:ptCount val="8"/>
                  <c:pt idx="0">
                    <c:v>8.0529420800537075</c:v>
                  </c:pt>
                  <c:pt idx="1">
                    <c:v>10.6</c:v>
                  </c:pt>
                  <c:pt idx="2">
                    <c:v>9.4</c:v>
                  </c:pt>
                  <c:pt idx="3">
                    <c:v>9.8503827289596551</c:v>
                  </c:pt>
                  <c:pt idx="4">
                    <c:v>10.319884666174406</c:v>
                  </c:pt>
                  <c:pt idx="5">
                    <c:v>9.8000000000000007</c:v>
                  </c:pt>
                  <c:pt idx="6">
                    <c:v>10.301295767913397</c:v>
                  </c:pt>
                  <c:pt idx="7">
                    <c:v>9.2343538003931744</c:v>
                  </c:pt>
                </c:numCache>
              </c:numRef>
            </c:plus>
            <c:minus>
              <c:numRef>
                <c:f>('Figure MDR-TB'!$D$16;'Figure MDR-TB'!$H$16;'Figure MDR-TB'!$L$16;'Figure MDR-TB'!$P$16;'Figure MDR-TB'!$T$16;'Figure MDR-TB'!$X$16;'Figure MDR-TB'!$AB$16;'Figure MDR-TB'!$AF$16)</c:f>
                <c:numCache>
                  <c:formatCode>General</c:formatCode>
                  <c:ptCount val="8"/>
                  <c:pt idx="0">
                    <c:v>8.0529420800537075</c:v>
                  </c:pt>
                  <c:pt idx="1">
                    <c:v>10.6</c:v>
                  </c:pt>
                  <c:pt idx="2">
                    <c:v>9.4</c:v>
                  </c:pt>
                  <c:pt idx="3">
                    <c:v>9.8503827289596551</c:v>
                  </c:pt>
                  <c:pt idx="4">
                    <c:v>10.319884666174406</c:v>
                  </c:pt>
                  <c:pt idx="5">
                    <c:v>9.8000000000000007</c:v>
                  </c:pt>
                  <c:pt idx="6">
                    <c:v>10.301295767913397</c:v>
                  </c:pt>
                  <c:pt idx="7">
                    <c:v>9.2343538003931744</c:v>
                  </c:pt>
                </c:numCache>
              </c:numRef>
            </c:minus>
          </c:errBars>
          <c:cat>
            <c:strRef>
              <c:f>('Figure MDR-TB'!$C$14;'Figure MDR-TB'!$G$14;'Figure MDR-TB'!$K$14;'Figure MDR-TB'!$O$14;'Figure MDR-TB'!$S$14;'Figure MDR-TB'!$W$14;'Figure MDR-TB'!$AA$14;'Figure MDR-TB'!$AE$14)</c:f>
              <c:strCache>
                <c:ptCount val="8"/>
                <c:pt idx="0">
                  <c:v>I</c:v>
                </c:pt>
                <c:pt idx="1">
                  <c:v>II</c:v>
                </c:pt>
                <c:pt idx="2">
                  <c:v>III</c:v>
                </c:pt>
                <c:pt idx="3">
                  <c:v>IV</c:v>
                </c:pt>
                <c:pt idx="4">
                  <c:v>V</c:v>
                </c:pt>
                <c:pt idx="5">
                  <c:v>VI</c:v>
                </c:pt>
                <c:pt idx="6">
                  <c:v>VII</c:v>
                </c:pt>
                <c:pt idx="7">
                  <c:v>VIII</c:v>
                </c:pt>
              </c:strCache>
            </c:strRef>
          </c:cat>
          <c:val>
            <c:numRef>
              <c:f>('Figure MDR-TB'!$C$16;'Figure MDR-TB'!$G$16;'Figure MDR-TB'!$K$16;'Figure MDR-TB'!$O$16;'Figure MDR-TB'!$S$16;'Figure MDR-TB'!$W$16;'Figure MDR-TB'!$AA$16;'Figure MDR-TB'!$AE$16)</c:f>
              <c:numCache>
                <c:formatCode>###0.0</c:formatCode>
                <c:ptCount val="8"/>
                <c:pt idx="0">
                  <c:v>82.608695652173878</c:v>
                </c:pt>
                <c:pt idx="1">
                  <c:v>52.2</c:v>
                </c:pt>
                <c:pt idx="2">
                  <c:v>73.913043478260931</c:v>
                </c:pt>
                <c:pt idx="3">
                  <c:v>69.565217391304344</c:v>
                </c:pt>
                <c:pt idx="4">
                  <c:v>60.869565217391305</c:v>
                </c:pt>
                <c:pt idx="5">
                  <c:v>34.782608695652151</c:v>
                </c:pt>
                <c:pt idx="6">
                  <c:v>60.869565217391305</c:v>
                </c:pt>
                <c:pt idx="7">
                  <c:v>26.086956521739129</c:v>
                </c:pt>
              </c:numCache>
            </c:numRef>
          </c:val>
        </c:ser>
        <c:ser>
          <c:idx val="1"/>
          <c:order val="1"/>
          <c:tx>
            <c:v>Non-Poor</c:v>
          </c:tx>
          <c:errBars>
            <c:errBarType val="both"/>
            <c:errValType val="cust"/>
            <c:plus>
              <c:numRef>
                <c:f>('Figure MDR-TB'!$F$16;'Figure MDR-TB'!$J$16;'Figure MDR-TB'!$N$16;'Figure MDR-TB'!$R$16;'Figure MDR-TB'!$V$16;'Figure MDR-TB'!$Z$16;'Figure MDR-TB'!$AD$16;'Figure MDR-TB'!$AH$16)</c:f>
                <c:numCache>
                  <c:formatCode>General</c:formatCode>
                  <c:ptCount val="8"/>
                  <c:pt idx="0">
                    <c:v>5.7962026592393734</c:v>
                  </c:pt>
                  <c:pt idx="1">
                    <c:v>6.8</c:v>
                  </c:pt>
                  <c:pt idx="2">
                    <c:v>6.3</c:v>
                  </c:pt>
                  <c:pt idx="3">
                    <c:v>7.9</c:v>
                  </c:pt>
                  <c:pt idx="4">
                    <c:v>8.1</c:v>
                  </c:pt>
                  <c:pt idx="5">
                    <c:v>7.7</c:v>
                  </c:pt>
                  <c:pt idx="6">
                    <c:v>8</c:v>
                  </c:pt>
                  <c:pt idx="7">
                    <c:v>7.7</c:v>
                  </c:pt>
                </c:numCache>
              </c:numRef>
            </c:plus>
            <c:minus>
              <c:numRef>
                <c:f>('Figure MDR-TB'!$F$16;'Figure MDR-TB'!$J$16;'Figure MDR-TB'!$N$16;'Figure MDR-TB'!$R$16;'Figure MDR-TB'!$V$16;'Figure MDR-TB'!$Z$16;'Figure MDR-TB'!$AD$16;'Figure MDR-TB'!$AH$16)</c:f>
                <c:numCache>
                  <c:formatCode>General</c:formatCode>
                  <c:ptCount val="8"/>
                  <c:pt idx="0">
                    <c:v>5.7962026592393734</c:v>
                  </c:pt>
                  <c:pt idx="1">
                    <c:v>6.8</c:v>
                  </c:pt>
                  <c:pt idx="2">
                    <c:v>6.3</c:v>
                  </c:pt>
                  <c:pt idx="3">
                    <c:v>7.9</c:v>
                  </c:pt>
                  <c:pt idx="4">
                    <c:v>8.1</c:v>
                  </c:pt>
                  <c:pt idx="5">
                    <c:v>7.7</c:v>
                  </c:pt>
                  <c:pt idx="6">
                    <c:v>8</c:v>
                  </c:pt>
                  <c:pt idx="7">
                    <c:v>7.7</c:v>
                  </c:pt>
                </c:numCache>
              </c:numRef>
            </c:minus>
          </c:errBars>
          <c:cat>
            <c:strRef>
              <c:f>('Figure MDR-TB'!$C$14;'Figure MDR-TB'!$G$14;'Figure MDR-TB'!$K$14;'Figure MDR-TB'!$O$14;'Figure MDR-TB'!$S$14;'Figure MDR-TB'!$W$14;'Figure MDR-TB'!$AA$14;'Figure MDR-TB'!$AE$14)</c:f>
              <c:strCache>
                <c:ptCount val="8"/>
                <c:pt idx="0">
                  <c:v>I</c:v>
                </c:pt>
                <c:pt idx="1">
                  <c:v>II</c:v>
                </c:pt>
                <c:pt idx="2">
                  <c:v>III</c:v>
                </c:pt>
                <c:pt idx="3">
                  <c:v>IV</c:v>
                </c:pt>
                <c:pt idx="4">
                  <c:v>V</c:v>
                </c:pt>
                <c:pt idx="5">
                  <c:v>VI</c:v>
                </c:pt>
                <c:pt idx="6">
                  <c:v>VII</c:v>
                </c:pt>
                <c:pt idx="7">
                  <c:v>VIII</c:v>
                </c:pt>
              </c:strCache>
            </c:strRef>
          </c:cat>
          <c:val>
            <c:numRef>
              <c:f>('Figure MDR-TB'!$E$16;'Figure MDR-TB'!$I$16;'Figure MDR-TB'!$M$16;'Figure MDR-TB'!$Q$16;'Figure MDR-TB'!$U$16;'Figure MDR-TB'!$Y$16;'Figure MDR-TB'!$AC$16;'Figure MDR-TB'!$AG$16)</c:f>
              <c:numCache>
                <c:formatCode>###0.0</c:formatCode>
                <c:ptCount val="8"/>
                <c:pt idx="0">
                  <c:v>82.926829268292735</c:v>
                </c:pt>
                <c:pt idx="1">
                  <c:v>75.599999999999994</c:v>
                </c:pt>
                <c:pt idx="2">
                  <c:v>80.487804878048777</c:v>
                </c:pt>
                <c:pt idx="3">
                  <c:v>65.853658536585286</c:v>
                </c:pt>
                <c:pt idx="4">
                  <c:v>60.975609756097533</c:v>
                </c:pt>
                <c:pt idx="5">
                  <c:v>39</c:v>
                </c:pt>
                <c:pt idx="6">
                  <c:v>63.414634146341434</c:v>
                </c:pt>
                <c:pt idx="7">
                  <c:v>39.024390243902438</c:v>
                </c:pt>
              </c:numCache>
            </c:numRef>
          </c:val>
        </c:ser>
        <c:axId val="189794176"/>
        <c:axId val="189795712"/>
      </c:barChart>
      <c:catAx>
        <c:axId val="189794176"/>
        <c:scaling>
          <c:orientation val="minMax"/>
        </c:scaling>
        <c:axPos val="b"/>
        <c:tickLblPos val="nextTo"/>
        <c:txPr>
          <a:bodyPr/>
          <a:lstStyle/>
          <a:p>
            <a:pPr>
              <a:defRPr>
                <a:latin typeface="Myriad Pro Light" pitchFamily="34" charset="0"/>
              </a:defRPr>
            </a:pPr>
            <a:endParaRPr lang="en-US"/>
          </a:p>
        </c:txPr>
        <c:crossAx val="189795712"/>
        <c:crosses val="autoZero"/>
        <c:auto val="1"/>
        <c:lblAlgn val="ctr"/>
        <c:lblOffset val="100"/>
      </c:catAx>
      <c:valAx>
        <c:axId val="189795712"/>
        <c:scaling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Incidence of catastrophic costs (%)</a:t>
                </a:r>
              </a:p>
            </c:rich>
          </c:tx>
          <c:layout/>
        </c:title>
        <c:numFmt formatCode="#,##0" sourceLinked="0"/>
        <c:tickLblPos val="nextTo"/>
        <c:txPr>
          <a:bodyPr/>
          <a:lstStyle/>
          <a:p>
            <a:pPr>
              <a:defRPr>
                <a:latin typeface="Myriad Pro Light" pitchFamily="34" charset="0"/>
              </a:defRPr>
            </a:pPr>
            <a:endParaRPr lang="en-US"/>
          </a:p>
        </c:txPr>
        <c:crossAx val="189794176"/>
        <c:crosses val="autoZero"/>
        <c:crossBetween val="between"/>
      </c:valAx>
    </c:plotArea>
    <c:plotVisOnly val="1"/>
    <c:dispBlanksAs val="gap"/>
  </c:chart>
  <c:txPr>
    <a:bodyPr/>
    <a:lstStyle/>
    <a:p>
      <a:pPr>
        <a:defRPr>
          <a:latin typeface="Myriad Pro" pitchFamily="34" charset="0"/>
        </a:defRPr>
      </a:pPr>
      <a:endParaRPr lang="en-US"/>
    </a:p>
  </c:tx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/>
      <c:barChart>
        <c:barDir val="col"/>
        <c:grouping val="clustered"/>
        <c:ser>
          <c:idx val="0"/>
          <c:order val="0"/>
          <c:tx>
            <c:v>Poor</c:v>
          </c:tx>
          <c:errBars>
            <c:errBarType val="both"/>
            <c:errValType val="cust"/>
            <c:plus>
              <c:numRef>
                <c:f>('Figure MDR-TB'!$D$21;'Figure MDR-TB'!$H$21;'Figure MDR-TB'!$L$21;'Figure MDR-TB'!$P$21;'Figure MDR-TB'!$T$21;'Figure MDR-TB'!$X$21;'Figure MDR-TB'!$AB$21;'Figure MDR-TB'!$AF$21)</c:f>
                <c:numCache>
                  <c:formatCode>General</c:formatCode>
                  <c:ptCount val="8"/>
                  <c:pt idx="0">
                    <c:v>8.0529420800537075</c:v>
                  </c:pt>
                  <c:pt idx="1">
                    <c:v>10.6</c:v>
                  </c:pt>
                  <c:pt idx="2">
                    <c:v>9.4</c:v>
                  </c:pt>
                  <c:pt idx="3">
                    <c:v>9.6</c:v>
                  </c:pt>
                  <c:pt idx="4">
                    <c:v>9.8000000000000007</c:v>
                  </c:pt>
                  <c:pt idx="5">
                    <c:v>10.200000000000001</c:v>
                  </c:pt>
                  <c:pt idx="6">
                    <c:v>10.301295767913397</c:v>
                  </c:pt>
                  <c:pt idx="7">
                    <c:v>9.2000000000000011</c:v>
                  </c:pt>
                </c:numCache>
              </c:numRef>
            </c:plus>
            <c:minus>
              <c:numRef>
                <c:f>('Figure MDR-TB'!$D$21;'Figure MDR-TB'!$H$21;'Figure MDR-TB'!$L$21;'Figure MDR-TB'!$P$21;'Figure MDR-TB'!$T$21;'Figure MDR-TB'!$X$21;'Figure MDR-TB'!$AB$21;'Figure MDR-TB'!$AF$21)</c:f>
                <c:numCache>
                  <c:formatCode>General</c:formatCode>
                  <c:ptCount val="8"/>
                  <c:pt idx="0">
                    <c:v>8.0529420800537075</c:v>
                  </c:pt>
                  <c:pt idx="1">
                    <c:v>10.6</c:v>
                  </c:pt>
                  <c:pt idx="2">
                    <c:v>9.4</c:v>
                  </c:pt>
                  <c:pt idx="3">
                    <c:v>9.6</c:v>
                  </c:pt>
                  <c:pt idx="4">
                    <c:v>9.8000000000000007</c:v>
                  </c:pt>
                  <c:pt idx="5">
                    <c:v>10.200000000000001</c:v>
                  </c:pt>
                  <c:pt idx="6">
                    <c:v>10.301295767913397</c:v>
                  </c:pt>
                  <c:pt idx="7">
                    <c:v>9.2000000000000011</c:v>
                  </c:pt>
                </c:numCache>
              </c:numRef>
            </c:minus>
          </c:errBars>
          <c:cat>
            <c:strRef>
              <c:f>('Figure MDR-TB'!$C$19;'Figure MDR-TB'!$G$19;'Figure MDR-TB'!$K$19;'Figure MDR-TB'!$O$19;'Figure MDR-TB'!$S$19;'Figure MDR-TB'!$W$19;'Figure MDR-TB'!$AA$19;'Figure MDR-TB'!$AE$19)</c:f>
              <c:strCache>
                <c:ptCount val="8"/>
                <c:pt idx="0">
                  <c:v>I</c:v>
                </c:pt>
                <c:pt idx="1">
                  <c:v>II</c:v>
                </c:pt>
                <c:pt idx="2">
                  <c:v>III</c:v>
                </c:pt>
                <c:pt idx="3">
                  <c:v>IV</c:v>
                </c:pt>
                <c:pt idx="4">
                  <c:v>V</c:v>
                </c:pt>
                <c:pt idx="5">
                  <c:v>VI</c:v>
                </c:pt>
                <c:pt idx="6">
                  <c:v>VII</c:v>
                </c:pt>
                <c:pt idx="7">
                  <c:v>VIII</c:v>
                </c:pt>
              </c:strCache>
            </c:strRef>
          </c:cat>
          <c:val>
            <c:numRef>
              <c:f>('Figure MDR-TB'!$C$21;'Figure MDR-TB'!$G$21;'Figure MDR-TB'!$K$21;'Figure MDR-TB'!$O$21;'Figure MDR-TB'!$S$21;'Figure MDR-TB'!$W$21;'Figure MDR-TB'!$AA$21;'Figure MDR-TB'!$AE$21)</c:f>
              <c:numCache>
                <c:formatCode>###0.0</c:formatCode>
                <c:ptCount val="8"/>
                <c:pt idx="0">
                  <c:v>82.608695652173878</c:v>
                </c:pt>
                <c:pt idx="1">
                  <c:v>52.2</c:v>
                </c:pt>
                <c:pt idx="2">
                  <c:v>73.913043478260931</c:v>
                </c:pt>
                <c:pt idx="3">
                  <c:v>73.913043478260931</c:v>
                </c:pt>
                <c:pt idx="4">
                  <c:v>69.565217391304344</c:v>
                </c:pt>
                <c:pt idx="5">
                  <c:v>39.1</c:v>
                </c:pt>
                <c:pt idx="6">
                  <c:v>60.869565217391305</c:v>
                </c:pt>
                <c:pt idx="7">
                  <c:v>26.1</c:v>
                </c:pt>
              </c:numCache>
            </c:numRef>
          </c:val>
        </c:ser>
        <c:ser>
          <c:idx val="1"/>
          <c:order val="1"/>
          <c:tx>
            <c:v>Non-Poor</c:v>
          </c:tx>
          <c:errBars>
            <c:errBarType val="both"/>
            <c:errValType val="cust"/>
            <c:plus>
              <c:numRef>
                <c:f>('Figure MDR-TB'!$F$21;'Figure MDR-TB'!$J$21;'Figure MDR-TB'!$N$21;'Figure MDR-TB'!$R$21;'Figure MDR-TB'!$V$21;'Figure MDR-TB'!$Z$21;'Figure MDR-TB'!$AD$21;'Figure MDR-TB'!$AH$21)</c:f>
                <c:numCache>
                  <c:formatCode>General</c:formatCode>
                  <c:ptCount val="8"/>
                  <c:pt idx="0">
                    <c:v>5.7962026592393734</c:v>
                  </c:pt>
                  <c:pt idx="1">
                    <c:v>6.6</c:v>
                  </c:pt>
                  <c:pt idx="2">
                    <c:v>6.3</c:v>
                  </c:pt>
                  <c:pt idx="3">
                    <c:v>7.1</c:v>
                  </c:pt>
                  <c:pt idx="4">
                    <c:v>7.5</c:v>
                  </c:pt>
                  <c:pt idx="5">
                    <c:v>8.1</c:v>
                  </c:pt>
                  <c:pt idx="6">
                    <c:v>7.9</c:v>
                  </c:pt>
                  <c:pt idx="7">
                    <c:v>7.9</c:v>
                  </c:pt>
                </c:numCache>
              </c:numRef>
            </c:plus>
            <c:minus>
              <c:numRef>
                <c:f>('Figure MDR-TB'!$F$21;'Figure MDR-TB'!$J$21;'Figure MDR-TB'!$N$21;'Figure MDR-TB'!$R$21;'Figure MDR-TB'!$V$21;'Figure MDR-TB'!$Z$21;'Figure MDR-TB'!$AD$21;'Figure MDR-TB'!$AH$21)</c:f>
                <c:numCache>
                  <c:formatCode>General</c:formatCode>
                  <c:ptCount val="8"/>
                  <c:pt idx="0">
                    <c:v>5.7962026592393734</c:v>
                  </c:pt>
                  <c:pt idx="1">
                    <c:v>6.6</c:v>
                  </c:pt>
                  <c:pt idx="2">
                    <c:v>6.3</c:v>
                  </c:pt>
                  <c:pt idx="3">
                    <c:v>7.1</c:v>
                  </c:pt>
                  <c:pt idx="4">
                    <c:v>7.5</c:v>
                  </c:pt>
                  <c:pt idx="5">
                    <c:v>8.1</c:v>
                  </c:pt>
                  <c:pt idx="6">
                    <c:v>7.9</c:v>
                  </c:pt>
                  <c:pt idx="7">
                    <c:v>7.9</c:v>
                  </c:pt>
                </c:numCache>
              </c:numRef>
            </c:minus>
          </c:errBars>
          <c:cat>
            <c:strRef>
              <c:f>('Figure MDR-TB'!$C$19;'Figure MDR-TB'!$G$19;'Figure MDR-TB'!$K$19;'Figure MDR-TB'!$O$19;'Figure MDR-TB'!$S$19;'Figure MDR-TB'!$W$19;'Figure MDR-TB'!$AA$19;'Figure MDR-TB'!$AE$19)</c:f>
              <c:strCache>
                <c:ptCount val="8"/>
                <c:pt idx="0">
                  <c:v>I</c:v>
                </c:pt>
                <c:pt idx="1">
                  <c:v>II</c:v>
                </c:pt>
                <c:pt idx="2">
                  <c:v>III</c:v>
                </c:pt>
                <c:pt idx="3">
                  <c:v>IV</c:v>
                </c:pt>
                <c:pt idx="4">
                  <c:v>V</c:v>
                </c:pt>
                <c:pt idx="5">
                  <c:v>VI</c:v>
                </c:pt>
                <c:pt idx="6">
                  <c:v>VII</c:v>
                </c:pt>
                <c:pt idx="7">
                  <c:v>VIII</c:v>
                </c:pt>
              </c:strCache>
            </c:strRef>
          </c:cat>
          <c:val>
            <c:numRef>
              <c:f>('Figure MDR-TB'!$E$21;'Figure MDR-TB'!$I$21;'Figure MDR-TB'!$M$21;'Figure MDR-TB'!$Q$21;'Figure MDR-TB'!$U$21;'Figure MDR-TB'!$Y$21;'Figure MDR-TB'!$AC$21;'Figure MDR-TB'!$AG$21)</c:f>
              <c:numCache>
                <c:formatCode>###0.0</c:formatCode>
                <c:ptCount val="8"/>
                <c:pt idx="0">
                  <c:v>82.926829268292735</c:v>
                </c:pt>
                <c:pt idx="1">
                  <c:v>78</c:v>
                </c:pt>
                <c:pt idx="2">
                  <c:v>80.487804878048777</c:v>
                </c:pt>
                <c:pt idx="3">
                  <c:v>73.170731707317032</c:v>
                </c:pt>
                <c:pt idx="4">
                  <c:v>68.292682926829258</c:v>
                </c:pt>
                <c:pt idx="5">
                  <c:v>51.2</c:v>
                </c:pt>
                <c:pt idx="6">
                  <c:v>65.853658536585286</c:v>
                </c:pt>
                <c:pt idx="7">
                  <c:v>43.9</c:v>
                </c:pt>
              </c:numCache>
            </c:numRef>
          </c:val>
        </c:ser>
        <c:axId val="189891328"/>
        <c:axId val="189892864"/>
      </c:barChart>
      <c:catAx>
        <c:axId val="189891328"/>
        <c:scaling>
          <c:orientation val="minMax"/>
        </c:scaling>
        <c:axPos val="b"/>
        <c:tickLblPos val="nextTo"/>
        <c:crossAx val="189892864"/>
        <c:crosses val="autoZero"/>
        <c:auto val="1"/>
        <c:lblAlgn val="ctr"/>
        <c:lblOffset val="100"/>
      </c:catAx>
      <c:valAx>
        <c:axId val="189892864"/>
        <c:scaling>
          <c:orientation val="minMax"/>
          <c:max val="100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Incidence of catastrophic costs (%)</a:t>
                </a:r>
              </a:p>
            </c:rich>
          </c:tx>
          <c:layout/>
        </c:title>
        <c:numFmt formatCode="#,##0" sourceLinked="0"/>
        <c:tickLblPos val="nextTo"/>
        <c:crossAx val="189891328"/>
        <c:crosses val="autoZero"/>
        <c:crossBetween val="between"/>
      </c:valAx>
    </c:plotArea>
    <c:plotVisOnly val="1"/>
    <c:dispBlanksAs val="gap"/>
  </c:chart>
  <c:txPr>
    <a:bodyPr/>
    <a:lstStyle/>
    <a:p>
      <a:pPr>
        <a:defRPr>
          <a:latin typeface="Myriad Pro Light" pitchFamily="34" charset="0"/>
        </a:defRPr>
      </a:pPr>
      <a:endParaRPr lang="en-US"/>
    </a:p>
  </c:txPr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/>
      <c:barChart>
        <c:barDir val="col"/>
        <c:grouping val="clustered"/>
        <c:ser>
          <c:idx val="0"/>
          <c:order val="0"/>
          <c:tx>
            <c:v>Poor</c:v>
          </c:tx>
          <c:errBars>
            <c:errBarType val="both"/>
            <c:errValType val="cust"/>
            <c:plus>
              <c:numRef>
                <c:f>('Figure MDR-TB'!$D$26;'Figure MDR-TB'!$H$26;'Figure MDR-TB'!$L$26;'Figure MDR-TB'!$P$26;'Figure MDR-TB'!$T$26;'Figure MDR-TB'!$X$26;'Figure MDR-TB'!$AB$26;'Figure MDR-TB'!$AF$26)</c:f>
                <c:numCache>
                  <c:formatCode>General</c:formatCode>
                  <c:ptCount val="8"/>
                  <c:pt idx="0">
                    <c:v>8.0529420800537075</c:v>
                  </c:pt>
                  <c:pt idx="1">
                    <c:v>10.4</c:v>
                  </c:pt>
                  <c:pt idx="2">
                    <c:v>9.4</c:v>
                  </c:pt>
                  <c:pt idx="3">
                    <c:v>9.6</c:v>
                  </c:pt>
                  <c:pt idx="4">
                    <c:v>9.8000000000000007</c:v>
                  </c:pt>
                  <c:pt idx="5">
                    <c:v>10.5</c:v>
                  </c:pt>
                  <c:pt idx="6">
                    <c:v>10.200000000000001</c:v>
                  </c:pt>
                  <c:pt idx="7">
                    <c:v>10.200000000000001</c:v>
                  </c:pt>
                </c:numCache>
              </c:numRef>
            </c:plus>
            <c:minus>
              <c:numRef>
                <c:f>('Figure MDR-TB'!$D$26;'Figure MDR-TB'!$H$26;'Figure MDR-TB'!$L$26;'Figure MDR-TB'!$P$26;'Figure MDR-TB'!$T$26;'Figure MDR-TB'!$X$26;'Figure MDR-TB'!$AB$26;'Figure MDR-TB'!$AF$26)</c:f>
                <c:numCache>
                  <c:formatCode>General</c:formatCode>
                  <c:ptCount val="8"/>
                  <c:pt idx="0">
                    <c:v>8.0529420800537075</c:v>
                  </c:pt>
                  <c:pt idx="1">
                    <c:v>10.4</c:v>
                  </c:pt>
                  <c:pt idx="2">
                    <c:v>9.4</c:v>
                  </c:pt>
                  <c:pt idx="3">
                    <c:v>9.6</c:v>
                  </c:pt>
                  <c:pt idx="4">
                    <c:v>9.8000000000000007</c:v>
                  </c:pt>
                  <c:pt idx="5">
                    <c:v>10.5</c:v>
                  </c:pt>
                  <c:pt idx="6">
                    <c:v>10.200000000000001</c:v>
                  </c:pt>
                  <c:pt idx="7">
                    <c:v>10.200000000000001</c:v>
                  </c:pt>
                </c:numCache>
              </c:numRef>
            </c:minus>
          </c:errBars>
          <c:cat>
            <c:strRef>
              <c:f>('Figure MDR-TB'!$C$24;'Figure MDR-TB'!$G$24;'Figure MDR-TB'!$K$24;'Figure MDR-TB'!$O$24;'Figure MDR-TB'!$S$24;'Figure MDR-TB'!$W$24;'Figure MDR-TB'!$AA$24;'Figure MDR-TB'!$AE$24)</c:f>
              <c:strCache>
                <c:ptCount val="8"/>
                <c:pt idx="0">
                  <c:v>I</c:v>
                </c:pt>
                <c:pt idx="1">
                  <c:v>II</c:v>
                </c:pt>
                <c:pt idx="2">
                  <c:v>III</c:v>
                </c:pt>
                <c:pt idx="3">
                  <c:v>IV</c:v>
                </c:pt>
                <c:pt idx="4">
                  <c:v>V</c:v>
                </c:pt>
                <c:pt idx="5">
                  <c:v>VI</c:v>
                </c:pt>
                <c:pt idx="6">
                  <c:v>VII</c:v>
                </c:pt>
                <c:pt idx="7">
                  <c:v>VIII</c:v>
                </c:pt>
              </c:strCache>
            </c:strRef>
          </c:cat>
          <c:val>
            <c:numRef>
              <c:f>('Figure MDR-TB'!$C$26;'Figure MDR-TB'!$G$26;'Figure MDR-TB'!$K$26;'Figure MDR-TB'!$O$26;'Figure MDR-TB'!$S$26;'Figure MDR-TB'!$W$26;'Figure MDR-TB'!$AA$26;'Figure MDR-TB'!$AE$26)</c:f>
              <c:numCache>
                <c:formatCode>###0.0</c:formatCode>
                <c:ptCount val="8"/>
                <c:pt idx="0">
                  <c:v>82.608695652173878</c:v>
                </c:pt>
                <c:pt idx="1">
                  <c:v>60.9</c:v>
                </c:pt>
                <c:pt idx="2">
                  <c:v>73.913043478260931</c:v>
                </c:pt>
                <c:pt idx="3">
                  <c:v>73.913043478260931</c:v>
                </c:pt>
                <c:pt idx="4">
                  <c:v>69.565217391304344</c:v>
                </c:pt>
                <c:pt idx="5">
                  <c:v>43.5</c:v>
                </c:pt>
                <c:pt idx="6">
                  <c:v>65.217391304347871</c:v>
                </c:pt>
                <c:pt idx="7">
                  <c:v>39.130434782608695</c:v>
                </c:pt>
              </c:numCache>
            </c:numRef>
          </c:val>
        </c:ser>
        <c:ser>
          <c:idx val="1"/>
          <c:order val="1"/>
          <c:tx>
            <c:v>Non-Poor</c:v>
          </c:tx>
          <c:errBars>
            <c:errBarType val="both"/>
            <c:errValType val="cust"/>
            <c:plus>
              <c:numRef>
                <c:f>('Figure MDR-TB'!$F$26;'Figure MDR-TB'!$J$26;'Figure MDR-TB'!$N$26;'Figure MDR-TB'!$R$26;'Figure MDR-TB'!$V$26;'Figure MDR-TB'!$Z$26;'Figure MDR-TB'!$AD$26;'Figure MDR-TB'!$AH$26)</c:f>
                <c:numCache>
                  <c:formatCode>General</c:formatCode>
                  <c:ptCount val="8"/>
                  <c:pt idx="0">
                    <c:v>5.7962026592393734</c:v>
                  </c:pt>
                  <c:pt idx="1">
                    <c:v>6.3</c:v>
                  </c:pt>
                  <c:pt idx="2">
                    <c:v>6.3</c:v>
                  </c:pt>
                  <c:pt idx="3">
                    <c:v>7.1</c:v>
                  </c:pt>
                  <c:pt idx="4">
                    <c:v>7.5</c:v>
                  </c:pt>
                  <c:pt idx="5">
                    <c:v>7.9</c:v>
                  </c:pt>
                  <c:pt idx="6">
                    <c:v>7.1</c:v>
                  </c:pt>
                  <c:pt idx="7">
                    <c:v>7.9</c:v>
                  </c:pt>
                </c:numCache>
              </c:numRef>
            </c:plus>
            <c:minus>
              <c:numRef>
                <c:f>('Figure MDR-TB'!$F$26;'Figure MDR-TB'!$J$26;'Figure MDR-TB'!$N$26;'Figure MDR-TB'!$R$26;'Figure MDR-TB'!$V$26;'Figure MDR-TB'!$Z$26;'Figure MDR-TB'!$AD$26;'Figure MDR-TB'!$AH$26)</c:f>
                <c:numCache>
                  <c:formatCode>General</c:formatCode>
                  <c:ptCount val="8"/>
                  <c:pt idx="0">
                    <c:v>5.7962026592393734</c:v>
                  </c:pt>
                  <c:pt idx="1">
                    <c:v>6.3</c:v>
                  </c:pt>
                  <c:pt idx="2">
                    <c:v>6.3</c:v>
                  </c:pt>
                  <c:pt idx="3">
                    <c:v>7.1</c:v>
                  </c:pt>
                  <c:pt idx="4">
                    <c:v>7.5</c:v>
                  </c:pt>
                  <c:pt idx="5">
                    <c:v>7.9</c:v>
                  </c:pt>
                  <c:pt idx="6">
                    <c:v>7.1</c:v>
                  </c:pt>
                  <c:pt idx="7">
                    <c:v>7.9</c:v>
                  </c:pt>
                </c:numCache>
              </c:numRef>
            </c:minus>
          </c:errBars>
          <c:cat>
            <c:strRef>
              <c:f>('Figure MDR-TB'!$C$24;'Figure MDR-TB'!$G$24;'Figure MDR-TB'!$K$24;'Figure MDR-TB'!$O$24;'Figure MDR-TB'!$S$24;'Figure MDR-TB'!$W$24;'Figure MDR-TB'!$AA$24;'Figure MDR-TB'!$AE$24)</c:f>
              <c:strCache>
                <c:ptCount val="8"/>
                <c:pt idx="0">
                  <c:v>I</c:v>
                </c:pt>
                <c:pt idx="1">
                  <c:v>II</c:v>
                </c:pt>
                <c:pt idx="2">
                  <c:v>III</c:v>
                </c:pt>
                <c:pt idx="3">
                  <c:v>IV</c:v>
                </c:pt>
                <c:pt idx="4">
                  <c:v>V</c:v>
                </c:pt>
                <c:pt idx="5">
                  <c:v>VI</c:v>
                </c:pt>
                <c:pt idx="6">
                  <c:v>VII</c:v>
                </c:pt>
                <c:pt idx="7">
                  <c:v>VIII</c:v>
                </c:pt>
              </c:strCache>
            </c:strRef>
          </c:cat>
          <c:val>
            <c:numRef>
              <c:f>('Figure MDR-TB'!$E$26;'Figure MDR-TB'!$I$26;'Figure MDR-TB'!$M$26;'Figure MDR-TB'!$Q$26;'Figure MDR-TB'!$U$26;'Figure MDR-TB'!$Y$26;'Figure MDR-TB'!$AC$26;'Figure MDR-TB'!$AG$26)</c:f>
              <c:numCache>
                <c:formatCode>###0.0</c:formatCode>
                <c:ptCount val="8"/>
                <c:pt idx="0">
                  <c:v>82.926829268292735</c:v>
                </c:pt>
                <c:pt idx="1">
                  <c:v>80.487804878048777</c:v>
                </c:pt>
                <c:pt idx="2">
                  <c:v>80.487804878048777</c:v>
                </c:pt>
                <c:pt idx="3">
                  <c:v>73.170731707317032</c:v>
                </c:pt>
                <c:pt idx="4">
                  <c:v>68.292682926829258</c:v>
                </c:pt>
                <c:pt idx="5">
                  <c:v>58.5</c:v>
                </c:pt>
                <c:pt idx="6">
                  <c:v>73.170731707317032</c:v>
                </c:pt>
                <c:pt idx="7">
                  <c:v>51.2</c:v>
                </c:pt>
              </c:numCache>
            </c:numRef>
          </c:val>
        </c:ser>
        <c:axId val="189975552"/>
        <c:axId val="189989632"/>
      </c:barChart>
      <c:catAx>
        <c:axId val="189975552"/>
        <c:scaling>
          <c:orientation val="minMax"/>
        </c:scaling>
        <c:axPos val="b"/>
        <c:tickLblPos val="nextTo"/>
        <c:crossAx val="189989632"/>
        <c:crosses val="autoZero"/>
        <c:auto val="1"/>
        <c:lblAlgn val="ctr"/>
        <c:lblOffset val="100"/>
      </c:catAx>
      <c:valAx>
        <c:axId val="189989632"/>
        <c:scaling>
          <c:orientation val="minMax"/>
          <c:max val="100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Incidence of catastrophic costs (%)</a:t>
                </a:r>
              </a:p>
            </c:rich>
          </c:tx>
          <c:layout/>
        </c:title>
        <c:numFmt formatCode="#,##0" sourceLinked="0"/>
        <c:tickLblPos val="nextTo"/>
        <c:crossAx val="189975552"/>
        <c:crosses val="autoZero"/>
        <c:crossBetween val="between"/>
      </c:valAx>
    </c:plotArea>
    <c:plotVisOnly val="1"/>
    <c:dispBlanksAs val="gap"/>
  </c:chart>
  <c:txPr>
    <a:bodyPr/>
    <a:lstStyle/>
    <a:p>
      <a:pPr>
        <a:defRPr>
          <a:latin typeface="Myriad Pro Light" pitchFamily="34" charset="0"/>
        </a:defRPr>
      </a:pPr>
      <a:endParaRPr lang="en-US"/>
    </a:p>
  </c:tx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D184B-81CB-4E47-AD2D-CEDA3FB79958}" type="datetimeFigureOut">
              <a:rPr lang="en-US" smtClean="0"/>
              <a:pPr/>
              <a:t>12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A03FE-6A68-4E97-9EFF-1BBD6618A7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09598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D184B-81CB-4E47-AD2D-CEDA3FB79958}" type="datetimeFigureOut">
              <a:rPr lang="en-US" smtClean="0"/>
              <a:pPr/>
              <a:t>12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A03FE-6A68-4E97-9EFF-1BBD6618A7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0652164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D184B-81CB-4E47-AD2D-CEDA3FB79958}" type="datetimeFigureOut">
              <a:rPr lang="en-US" smtClean="0"/>
              <a:pPr/>
              <a:t>12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A03FE-6A68-4E97-9EFF-1BBD6618A7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3245411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D184B-81CB-4E47-AD2D-CEDA3FB79958}" type="datetimeFigureOut">
              <a:rPr lang="en-US" smtClean="0"/>
              <a:pPr/>
              <a:t>12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A03FE-6A68-4E97-9EFF-1BBD6618A7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051755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D184B-81CB-4E47-AD2D-CEDA3FB79958}" type="datetimeFigureOut">
              <a:rPr lang="en-US" smtClean="0"/>
              <a:pPr/>
              <a:t>12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A03FE-6A68-4E97-9EFF-1BBD6618A7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9446561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D184B-81CB-4E47-AD2D-CEDA3FB79958}" type="datetimeFigureOut">
              <a:rPr lang="en-US" smtClean="0"/>
              <a:pPr/>
              <a:t>12/2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A03FE-6A68-4E97-9EFF-1BBD6618A7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4900791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D184B-81CB-4E47-AD2D-CEDA3FB79958}" type="datetimeFigureOut">
              <a:rPr lang="en-US" smtClean="0"/>
              <a:pPr/>
              <a:t>12/20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A03FE-6A68-4E97-9EFF-1BBD6618A7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3400227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D184B-81CB-4E47-AD2D-CEDA3FB79958}" type="datetimeFigureOut">
              <a:rPr lang="en-US" smtClean="0"/>
              <a:pPr/>
              <a:t>12/20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A03FE-6A68-4E97-9EFF-1BBD6618A7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6875309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D184B-81CB-4E47-AD2D-CEDA3FB79958}" type="datetimeFigureOut">
              <a:rPr lang="en-US" smtClean="0"/>
              <a:pPr/>
              <a:t>12/20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A03FE-6A68-4E97-9EFF-1BBD6618A7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302070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D184B-81CB-4E47-AD2D-CEDA3FB79958}" type="datetimeFigureOut">
              <a:rPr lang="en-US" smtClean="0"/>
              <a:pPr/>
              <a:t>12/2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A03FE-6A68-4E97-9EFF-1BBD6618A7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7278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D184B-81CB-4E47-AD2D-CEDA3FB79958}" type="datetimeFigureOut">
              <a:rPr lang="en-US" smtClean="0"/>
              <a:pPr/>
              <a:t>12/2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A03FE-6A68-4E97-9EFF-1BBD6618A7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3503624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0D184B-81CB-4E47-AD2D-CEDA3FB79958}" type="datetimeFigureOut">
              <a:rPr lang="en-US" smtClean="0"/>
              <a:pPr/>
              <a:t>12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0A03FE-6A68-4E97-9EFF-1BBD6618A7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833972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/>
        </p:nvGraphicFramePr>
        <p:xfrm>
          <a:off x="-38100" y="657225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2762007852"/>
              </p:ext>
            </p:extLst>
          </p:nvPr>
        </p:nvGraphicFramePr>
        <p:xfrm>
          <a:off x="4499992" y="657225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/>
        </p:nvGraphicFramePr>
        <p:xfrm>
          <a:off x="-38100" y="3457575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508406311"/>
              </p:ext>
            </p:extLst>
          </p:nvPr>
        </p:nvGraphicFramePr>
        <p:xfrm>
          <a:off x="4509517" y="3457575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3499146" y="785419"/>
            <a:ext cx="572593" cy="230832"/>
          </a:xfrm>
          <a:prstGeom prst="rect">
            <a:avLst/>
          </a:prstGeom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nl-NL" sz="900" dirty="0" smtClean="0">
                <a:latin typeface="Myriad Pro" pitchFamily="34" charset="0"/>
                <a:cs typeface="Arial" panose="020B0604020202020204" pitchFamily="34" charset="0"/>
              </a:rPr>
              <a:t>(a) 90%</a:t>
            </a:r>
            <a:endParaRPr lang="en-US" sz="900" dirty="0">
              <a:latin typeface="Myriad Pro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8028384" y="788484"/>
            <a:ext cx="580608" cy="230832"/>
          </a:xfrm>
          <a:prstGeom prst="rect">
            <a:avLst/>
          </a:prstGeom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nl-NL" sz="900" dirty="0" smtClean="0">
                <a:latin typeface="Myriad Pro" pitchFamily="34" charset="0"/>
                <a:cs typeface="Arial" panose="020B0604020202020204" pitchFamily="34" charset="0"/>
              </a:rPr>
              <a:t>(b) 80%</a:t>
            </a:r>
            <a:endParaRPr lang="en-US" sz="900" dirty="0">
              <a:latin typeface="Myriad Pro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524215" y="3581544"/>
            <a:ext cx="562975" cy="230832"/>
          </a:xfrm>
          <a:prstGeom prst="rect">
            <a:avLst/>
          </a:prstGeom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nl-NL" sz="900" dirty="0" smtClean="0">
                <a:latin typeface="Myriad Pro" pitchFamily="34" charset="0"/>
                <a:cs typeface="Arial" panose="020B0604020202020204" pitchFamily="34" charset="0"/>
              </a:rPr>
              <a:t>(c) 70%</a:t>
            </a:r>
            <a:endParaRPr lang="en-US" sz="900" dirty="0">
              <a:latin typeface="Myriad Pro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8026728" y="3590472"/>
            <a:ext cx="580608" cy="230832"/>
          </a:xfrm>
          <a:prstGeom prst="rect">
            <a:avLst/>
          </a:prstGeom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nl-NL" sz="900" dirty="0" smtClean="0">
                <a:latin typeface="Myriad Pro" pitchFamily="34" charset="0"/>
                <a:cs typeface="Arial" panose="020B0604020202020204" pitchFamily="34" charset="0"/>
              </a:rPr>
              <a:t>(d) 60%</a:t>
            </a:r>
            <a:endParaRPr lang="en-US" sz="900" dirty="0">
              <a:latin typeface="Myriad Pro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9945771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0</TotalTime>
  <Words>40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Erasmus MC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. Fuady</dc:creator>
  <cp:lastModifiedBy>Fuady</cp:lastModifiedBy>
  <cp:revision>20</cp:revision>
  <dcterms:created xsi:type="dcterms:W3CDTF">2018-05-17T11:37:03Z</dcterms:created>
  <dcterms:modified xsi:type="dcterms:W3CDTF">2018-12-20T22:55:53Z</dcterms:modified>
</cp:coreProperties>
</file>